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A561075-0CC7-45AF-BA55-49A3C46B466F}" v="10" dt="2024-08-25T04:53:56.51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69" autoAdjust="0"/>
    <p:restoredTop sz="94660"/>
  </p:normalViewPr>
  <p:slideViewPr>
    <p:cSldViewPr snapToGrid="0">
      <p:cViewPr>
        <p:scale>
          <a:sx n="140" d="100"/>
          <a:sy n="140" d="100"/>
        </p:scale>
        <p:origin x="162" y="-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洋平 小澤" userId="16df1fc59ed41bf5" providerId="LiveId" clId="{BA561075-0CC7-45AF-BA55-49A3C46B466F}"/>
    <pc:docChg chg="undo custSel modSld">
      <pc:chgData name="洋平 小澤" userId="16df1fc59ed41bf5" providerId="LiveId" clId="{BA561075-0CC7-45AF-BA55-49A3C46B466F}" dt="2024-08-25T06:25:31.775" v="208" actId="20577"/>
      <pc:docMkLst>
        <pc:docMk/>
      </pc:docMkLst>
      <pc:sldChg chg="addSp delSp modSp mod">
        <pc:chgData name="洋平 小澤" userId="16df1fc59ed41bf5" providerId="LiveId" clId="{BA561075-0CC7-45AF-BA55-49A3C46B466F}" dt="2024-08-25T06:25:31.775" v="208" actId="20577"/>
        <pc:sldMkLst>
          <pc:docMk/>
          <pc:sldMk cId="307993105" sldId="256"/>
        </pc:sldMkLst>
        <pc:spChg chg="add mod">
          <ac:chgData name="洋平 小澤" userId="16df1fc59ed41bf5" providerId="LiveId" clId="{BA561075-0CC7-45AF-BA55-49A3C46B466F}" dt="2024-08-25T04:48:54.243" v="58" actId="1076"/>
          <ac:spMkLst>
            <pc:docMk/>
            <pc:sldMk cId="307993105" sldId="256"/>
            <ac:spMk id="2" creationId="{98146708-7A79-9AD1-86EF-DD95C9291D54}"/>
          </ac:spMkLst>
        </pc:spChg>
        <pc:spChg chg="add mod">
          <ac:chgData name="洋平 小澤" userId="16df1fc59ed41bf5" providerId="LiveId" clId="{BA561075-0CC7-45AF-BA55-49A3C46B466F}" dt="2024-08-25T04:47:17.406" v="16" actId="1076"/>
          <ac:spMkLst>
            <pc:docMk/>
            <pc:sldMk cId="307993105" sldId="256"/>
            <ac:spMk id="3" creationId="{9DD27DB3-7746-8ED4-8216-7F2EDC30EEAD}"/>
          </ac:spMkLst>
        </pc:spChg>
        <pc:spChg chg="add mod">
          <ac:chgData name="洋平 小澤" userId="16df1fc59ed41bf5" providerId="LiveId" clId="{BA561075-0CC7-45AF-BA55-49A3C46B466F}" dt="2024-08-25T04:48:43.406" v="54" actId="1076"/>
          <ac:spMkLst>
            <pc:docMk/>
            <pc:sldMk cId="307993105" sldId="256"/>
            <ac:spMk id="5" creationId="{8F778294-98D8-64E0-012A-EE67D816FBF0}"/>
          </ac:spMkLst>
        </pc:spChg>
        <pc:spChg chg="add mod">
          <ac:chgData name="洋平 小澤" userId="16df1fc59ed41bf5" providerId="LiveId" clId="{BA561075-0CC7-45AF-BA55-49A3C46B466F}" dt="2024-08-25T04:50:37.316" v="109" actId="1076"/>
          <ac:spMkLst>
            <pc:docMk/>
            <pc:sldMk cId="307993105" sldId="256"/>
            <ac:spMk id="9" creationId="{0A2BCC27-050A-1B47-37FE-9BD607348A61}"/>
          </ac:spMkLst>
        </pc:spChg>
        <pc:spChg chg="del">
          <ac:chgData name="洋平 小澤" userId="16df1fc59ed41bf5" providerId="LiveId" clId="{BA561075-0CC7-45AF-BA55-49A3C46B466F}" dt="2024-08-25T04:46:08.420" v="1" actId="478"/>
          <ac:spMkLst>
            <pc:docMk/>
            <pc:sldMk cId="307993105" sldId="256"/>
            <ac:spMk id="10" creationId="{71E963EC-7D33-C055-068B-FA7ED46EF078}"/>
          </ac:spMkLst>
        </pc:spChg>
        <pc:spChg chg="del">
          <ac:chgData name="洋平 小澤" userId="16df1fc59ed41bf5" providerId="LiveId" clId="{BA561075-0CC7-45AF-BA55-49A3C46B466F}" dt="2024-08-25T04:46:11.739" v="2" actId="478"/>
          <ac:spMkLst>
            <pc:docMk/>
            <pc:sldMk cId="307993105" sldId="256"/>
            <ac:spMk id="11" creationId="{8553AC49-3168-E154-D36C-75EA0D315F7C}"/>
          </ac:spMkLst>
        </pc:spChg>
        <pc:spChg chg="del">
          <ac:chgData name="洋平 小澤" userId="16df1fc59ed41bf5" providerId="LiveId" clId="{BA561075-0CC7-45AF-BA55-49A3C46B466F}" dt="2024-08-25T04:46:11.739" v="2" actId="478"/>
          <ac:spMkLst>
            <pc:docMk/>
            <pc:sldMk cId="307993105" sldId="256"/>
            <ac:spMk id="12" creationId="{E7407EBF-5686-E5DB-35D7-E8231DB158F1}"/>
          </ac:spMkLst>
        </pc:spChg>
        <pc:spChg chg="del">
          <ac:chgData name="洋平 小澤" userId="16df1fc59ed41bf5" providerId="LiveId" clId="{BA561075-0CC7-45AF-BA55-49A3C46B466F}" dt="2024-08-25T04:46:11.739" v="2" actId="478"/>
          <ac:spMkLst>
            <pc:docMk/>
            <pc:sldMk cId="307993105" sldId="256"/>
            <ac:spMk id="13" creationId="{295186F8-02B5-09A6-C3EE-86D674C9D6F3}"/>
          </ac:spMkLst>
        </pc:spChg>
        <pc:spChg chg="add mod">
          <ac:chgData name="洋平 小澤" userId="16df1fc59ed41bf5" providerId="LiveId" clId="{BA561075-0CC7-45AF-BA55-49A3C46B466F}" dt="2024-08-25T04:54:30.815" v="192" actId="1076"/>
          <ac:spMkLst>
            <pc:docMk/>
            <pc:sldMk cId="307993105" sldId="256"/>
            <ac:spMk id="14" creationId="{9A1CA37E-75CA-2B3D-C308-DD6993B31E47}"/>
          </ac:spMkLst>
        </pc:spChg>
        <pc:spChg chg="add mod">
          <ac:chgData name="洋平 小澤" userId="16df1fc59ed41bf5" providerId="LiveId" clId="{BA561075-0CC7-45AF-BA55-49A3C46B466F}" dt="2024-08-25T04:51:27.695" v="120" actId="14100"/>
          <ac:spMkLst>
            <pc:docMk/>
            <pc:sldMk cId="307993105" sldId="256"/>
            <ac:spMk id="15" creationId="{597E75CC-4A71-6705-24B4-0E1F9CCBCDC2}"/>
          </ac:spMkLst>
        </pc:spChg>
        <pc:spChg chg="mod">
          <ac:chgData name="洋平 小澤" userId="16df1fc59ed41bf5" providerId="LiveId" clId="{BA561075-0CC7-45AF-BA55-49A3C46B466F}" dt="2024-08-25T04:46:37.938" v="6" actId="1076"/>
          <ac:spMkLst>
            <pc:docMk/>
            <pc:sldMk cId="307993105" sldId="256"/>
            <ac:spMk id="18" creationId="{40A2250C-18E9-B99C-4DCA-4A39952E05BC}"/>
          </ac:spMkLst>
        </pc:spChg>
        <pc:spChg chg="mod">
          <ac:chgData name="洋平 小澤" userId="16df1fc59ed41bf5" providerId="LiveId" clId="{BA561075-0CC7-45AF-BA55-49A3C46B466F}" dt="2024-08-25T04:46:37.938" v="6" actId="1076"/>
          <ac:spMkLst>
            <pc:docMk/>
            <pc:sldMk cId="307993105" sldId="256"/>
            <ac:spMk id="19" creationId="{54053658-9FB8-266A-95DE-3E80FE43FADE}"/>
          </ac:spMkLst>
        </pc:spChg>
        <pc:spChg chg="mod">
          <ac:chgData name="洋平 小澤" userId="16df1fc59ed41bf5" providerId="LiveId" clId="{BA561075-0CC7-45AF-BA55-49A3C46B466F}" dt="2024-08-25T04:46:37.938" v="6" actId="1076"/>
          <ac:spMkLst>
            <pc:docMk/>
            <pc:sldMk cId="307993105" sldId="256"/>
            <ac:spMk id="20" creationId="{B1DFB857-E3B4-B333-1272-239F96DAEF85}"/>
          </ac:spMkLst>
        </pc:spChg>
        <pc:spChg chg="add mod">
          <ac:chgData name="洋平 小澤" userId="16df1fc59ed41bf5" providerId="LiveId" clId="{BA561075-0CC7-45AF-BA55-49A3C46B466F}" dt="2024-08-25T04:51:52.081" v="129" actId="1076"/>
          <ac:spMkLst>
            <pc:docMk/>
            <pc:sldMk cId="307993105" sldId="256"/>
            <ac:spMk id="21" creationId="{F515D816-9CDB-C4F8-97DC-DC3E4B92F09B}"/>
          </ac:spMkLst>
        </pc:spChg>
        <pc:spChg chg="mod">
          <ac:chgData name="洋平 小澤" userId="16df1fc59ed41bf5" providerId="LiveId" clId="{BA561075-0CC7-45AF-BA55-49A3C46B466F}" dt="2024-08-25T06:24:51.095" v="196" actId="20577"/>
          <ac:spMkLst>
            <pc:docMk/>
            <pc:sldMk cId="307993105" sldId="256"/>
            <ac:spMk id="23" creationId="{9F61D4F1-CC8F-86A7-30AB-567DE34B06D3}"/>
          </ac:spMkLst>
        </pc:spChg>
        <pc:spChg chg="add mod">
          <ac:chgData name="洋平 小澤" userId="16df1fc59ed41bf5" providerId="LiveId" clId="{BA561075-0CC7-45AF-BA55-49A3C46B466F}" dt="2024-08-25T04:52:10.711" v="138" actId="1076"/>
          <ac:spMkLst>
            <pc:docMk/>
            <pc:sldMk cId="307993105" sldId="256"/>
            <ac:spMk id="24" creationId="{B977D0EC-48BA-C352-FC45-E15AE1C27091}"/>
          </ac:spMkLst>
        </pc:spChg>
        <pc:spChg chg="del">
          <ac:chgData name="洋平 小澤" userId="16df1fc59ed41bf5" providerId="LiveId" clId="{BA561075-0CC7-45AF-BA55-49A3C46B466F}" dt="2024-08-25T04:46:17.109" v="4" actId="478"/>
          <ac:spMkLst>
            <pc:docMk/>
            <pc:sldMk cId="307993105" sldId="256"/>
            <ac:spMk id="26" creationId="{673A437E-7291-1015-30CD-E6F918A9F010}"/>
          </ac:spMkLst>
        </pc:spChg>
        <pc:spChg chg="del">
          <ac:chgData name="洋平 小澤" userId="16df1fc59ed41bf5" providerId="LiveId" clId="{BA561075-0CC7-45AF-BA55-49A3C46B466F}" dt="2024-08-25T04:46:15.932" v="3" actId="478"/>
          <ac:spMkLst>
            <pc:docMk/>
            <pc:sldMk cId="307993105" sldId="256"/>
            <ac:spMk id="27" creationId="{DCAB0841-E80D-382D-2B50-681721E3B4F8}"/>
          </ac:spMkLst>
        </pc:spChg>
        <pc:spChg chg="del">
          <ac:chgData name="洋平 小澤" userId="16df1fc59ed41bf5" providerId="LiveId" clId="{BA561075-0CC7-45AF-BA55-49A3C46B466F}" dt="2024-08-25T04:46:15.932" v="3" actId="478"/>
          <ac:spMkLst>
            <pc:docMk/>
            <pc:sldMk cId="307993105" sldId="256"/>
            <ac:spMk id="28" creationId="{EF250B89-996B-5F8E-A6B2-F4F786F4BBDA}"/>
          </ac:spMkLst>
        </pc:spChg>
        <pc:spChg chg="add mod">
          <ac:chgData name="洋平 小澤" userId="16df1fc59ed41bf5" providerId="LiveId" clId="{BA561075-0CC7-45AF-BA55-49A3C46B466F}" dt="2024-08-25T04:52:49.544" v="164" actId="1076"/>
          <ac:spMkLst>
            <pc:docMk/>
            <pc:sldMk cId="307993105" sldId="256"/>
            <ac:spMk id="29" creationId="{E36FA195-27AC-22AC-CCDF-A45081F83588}"/>
          </ac:spMkLst>
        </pc:spChg>
        <pc:spChg chg="mod">
          <ac:chgData name="洋平 小澤" userId="16df1fc59ed41bf5" providerId="LiveId" clId="{BA561075-0CC7-45AF-BA55-49A3C46B466F}" dt="2024-08-25T04:46:43.301" v="7" actId="1076"/>
          <ac:spMkLst>
            <pc:docMk/>
            <pc:sldMk cId="307993105" sldId="256"/>
            <ac:spMk id="31" creationId="{E0E75626-CA42-57AA-37C5-44DEF470310C}"/>
          </ac:spMkLst>
        </pc:spChg>
        <pc:spChg chg="mod">
          <ac:chgData name="洋平 小澤" userId="16df1fc59ed41bf5" providerId="LiveId" clId="{BA561075-0CC7-45AF-BA55-49A3C46B466F}" dt="2024-08-25T04:46:43.301" v="7" actId="1076"/>
          <ac:spMkLst>
            <pc:docMk/>
            <pc:sldMk cId="307993105" sldId="256"/>
            <ac:spMk id="32" creationId="{02D647A6-2720-648A-1AB9-9F09CD80AE5A}"/>
          </ac:spMkLst>
        </pc:spChg>
        <pc:spChg chg="mod">
          <ac:chgData name="洋平 小澤" userId="16df1fc59ed41bf5" providerId="LiveId" clId="{BA561075-0CC7-45AF-BA55-49A3C46B466F}" dt="2024-08-25T04:46:43.301" v="7" actId="1076"/>
          <ac:spMkLst>
            <pc:docMk/>
            <pc:sldMk cId="307993105" sldId="256"/>
            <ac:spMk id="33" creationId="{A91EF125-3AD9-7D04-5F35-F386DD280A69}"/>
          </ac:spMkLst>
        </pc:spChg>
        <pc:spChg chg="mod">
          <ac:chgData name="洋平 小澤" userId="16df1fc59ed41bf5" providerId="LiveId" clId="{BA561075-0CC7-45AF-BA55-49A3C46B466F}" dt="2024-08-25T06:25:04.911" v="200" actId="20577"/>
          <ac:spMkLst>
            <pc:docMk/>
            <pc:sldMk cId="307993105" sldId="256"/>
            <ac:spMk id="34" creationId="{3500B784-CB1E-964B-46CA-0C3281109D87}"/>
          </ac:spMkLst>
        </pc:spChg>
        <pc:spChg chg="del">
          <ac:chgData name="洋平 小澤" userId="16df1fc59ed41bf5" providerId="LiveId" clId="{BA561075-0CC7-45AF-BA55-49A3C46B466F}" dt="2024-08-25T04:46:15.932" v="3" actId="478"/>
          <ac:spMkLst>
            <pc:docMk/>
            <pc:sldMk cId="307993105" sldId="256"/>
            <ac:spMk id="35" creationId="{DE1B05D8-B06E-DB78-5430-2AA05B30FCCA}"/>
          </ac:spMkLst>
        </pc:spChg>
        <pc:spChg chg="add mod">
          <ac:chgData name="洋平 小澤" userId="16df1fc59ed41bf5" providerId="LiveId" clId="{BA561075-0CC7-45AF-BA55-49A3C46B466F}" dt="2024-08-25T04:54:13.307" v="189" actId="1076"/>
          <ac:spMkLst>
            <pc:docMk/>
            <pc:sldMk cId="307993105" sldId="256"/>
            <ac:spMk id="36" creationId="{F49BC9F0-514C-E998-3E8B-12BA18D299D6}"/>
          </ac:spMkLst>
        </pc:spChg>
        <pc:spChg chg="mod">
          <ac:chgData name="洋平 小澤" userId="16df1fc59ed41bf5" providerId="LiveId" clId="{BA561075-0CC7-45AF-BA55-49A3C46B466F}" dt="2024-08-25T04:46:43.301" v="7" actId="1076"/>
          <ac:spMkLst>
            <pc:docMk/>
            <pc:sldMk cId="307993105" sldId="256"/>
            <ac:spMk id="38" creationId="{F2A9EF1B-07A5-C1C4-81A2-05BE8C5F9E1C}"/>
          </ac:spMkLst>
        </pc:spChg>
        <pc:spChg chg="mod">
          <ac:chgData name="洋平 小澤" userId="16df1fc59ed41bf5" providerId="LiveId" clId="{BA561075-0CC7-45AF-BA55-49A3C46B466F}" dt="2024-08-25T04:46:43.301" v="7" actId="1076"/>
          <ac:spMkLst>
            <pc:docMk/>
            <pc:sldMk cId="307993105" sldId="256"/>
            <ac:spMk id="39" creationId="{A8401D04-C627-6B0E-C283-69326A68C250}"/>
          </ac:spMkLst>
        </pc:spChg>
        <pc:spChg chg="mod">
          <ac:chgData name="洋平 小澤" userId="16df1fc59ed41bf5" providerId="LiveId" clId="{BA561075-0CC7-45AF-BA55-49A3C46B466F}" dt="2024-08-25T04:46:43.301" v="7" actId="1076"/>
          <ac:spMkLst>
            <pc:docMk/>
            <pc:sldMk cId="307993105" sldId="256"/>
            <ac:spMk id="40" creationId="{B1959F97-4E9A-2A25-D878-7F58847F4595}"/>
          </ac:spMkLst>
        </pc:spChg>
        <pc:spChg chg="add del mod">
          <ac:chgData name="洋平 小澤" userId="16df1fc59ed41bf5" providerId="LiveId" clId="{BA561075-0CC7-45AF-BA55-49A3C46B466F}" dt="2024-08-25T04:53:04.542" v="168" actId="478"/>
          <ac:spMkLst>
            <pc:docMk/>
            <pc:sldMk cId="307993105" sldId="256"/>
            <ac:spMk id="41" creationId="{761843C0-D839-E920-0450-A6C18FA9AF4C}"/>
          </ac:spMkLst>
        </pc:spChg>
        <pc:spChg chg="mod">
          <ac:chgData name="洋平 小澤" userId="16df1fc59ed41bf5" providerId="LiveId" clId="{BA561075-0CC7-45AF-BA55-49A3C46B466F}" dt="2024-08-25T04:46:52.092" v="8" actId="1076"/>
          <ac:spMkLst>
            <pc:docMk/>
            <pc:sldMk cId="307993105" sldId="256"/>
            <ac:spMk id="43" creationId="{82E9381F-A69F-DB4D-751B-0410A2ABB17C}"/>
          </ac:spMkLst>
        </pc:spChg>
        <pc:spChg chg="mod">
          <ac:chgData name="洋平 小澤" userId="16df1fc59ed41bf5" providerId="LiveId" clId="{BA561075-0CC7-45AF-BA55-49A3C46B466F}" dt="2024-08-25T04:46:52.092" v="8" actId="1076"/>
          <ac:spMkLst>
            <pc:docMk/>
            <pc:sldMk cId="307993105" sldId="256"/>
            <ac:spMk id="44" creationId="{4931E3E7-411A-358B-A3D8-14BC9D47E98C}"/>
          </ac:spMkLst>
        </pc:spChg>
        <pc:spChg chg="mod">
          <ac:chgData name="洋平 小澤" userId="16df1fc59ed41bf5" providerId="LiveId" clId="{BA561075-0CC7-45AF-BA55-49A3C46B466F}" dt="2024-08-25T04:47:04.164" v="14" actId="1036"/>
          <ac:spMkLst>
            <pc:docMk/>
            <pc:sldMk cId="307993105" sldId="256"/>
            <ac:spMk id="45" creationId="{6C102864-D026-F21E-8F9A-78208F9DF795}"/>
          </ac:spMkLst>
        </pc:spChg>
        <pc:spChg chg="add mod">
          <ac:chgData name="洋平 小澤" userId="16df1fc59ed41bf5" providerId="LiveId" clId="{BA561075-0CC7-45AF-BA55-49A3C46B466F}" dt="2024-08-25T04:53:11.801" v="172" actId="1076"/>
          <ac:spMkLst>
            <pc:docMk/>
            <pc:sldMk cId="307993105" sldId="256"/>
            <ac:spMk id="46" creationId="{C2C22BE3-AAFD-89F3-1DB0-DE8DA086265D}"/>
          </ac:spMkLst>
        </pc:spChg>
        <pc:spChg chg="del">
          <ac:chgData name="洋平 小澤" userId="16df1fc59ed41bf5" providerId="LiveId" clId="{BA561075-0CC7-45AF-BA55-49A3C46B466F}" dt="2024-08-25T04:46:21.716" v="5" actId="478"/>
          <ac:spMkLst>
            <pc:docMk/>
            <pc:sldMk cId="307993105" sldId="256"/>
            <ac:spMk id="48" creationId="{F52E984E-640D-6B71-1C6B-0213ED9EC01A}"/>
          </ac:spMkLst>
        </pc:spChg>
        <pc:spChg chg="del">
          <ac:chgData name="洋平 小澤" userId="16df1fc59ed41bf5" providerId="LiveId" clId="{BA561075-0CC7-45AF-BA55-49A3C46B466F}" dt="2024-08-25T04:46:21.716" v="5" actId="478"/>
          <ac:spMkLst>
            <pc:docMk/>
            <pc:sldMk cId="307993105" sldId="256"/>
            <ac:spMk id="50" creationId="{AFB94B2E-019D-30F9-10C3-CEBC52A6EB68}"/>
          </ac:spMkLst>
        </pc:spChg>
        <pc:spChg chg="del">
          <ac:chgData name="洋平 小澤" userId="16df1fc59ed41bf5" providerId="LiveId" clId="{BA561075-0CC7-45AF-BA55-49A3C46B466F}" dt="2024-08-25T04:46:21.716" v="5" actId="478"/>
          <ac:spMkLst>
            <pc:docMk/>
            <pc:sldMk cId="307993105" sldId="256"/>
            <ac:spMk id="51" creationId="{19A7C25C-2E37-900C-38C2-8511383D84E8}"/>
          </ac:spMkLst>
        </pc:spChg>
        <pc:spChg chg="mod">
          <ac:chgData name="洋平 小澤" userId="16df1fc59ed41bf5" providerId="LiveId" clId="{BA561075-0CC7-45AF-BA55-49A3C46B466F}" dt="2024-08-25T06:25:16.617" v="202" actId="20577"/>
          <ac:spMkLst>
            <pc:docMk/>
            <pc:sldMk cId="307993105" sldId="256"/>
            <ac:spMk id="52" creationId="{86F5AF9F-CB5C-6DD9-CEBB-51C52466F389}"/>
          </ac:spMkLst>
        </pc:spChg>
        <pc:spChg chg="mod">
          <ac:chgData name="洋平 小澤" userId="16df1fc59ed41bf5" providerId="LiveId" clId="{BA561075-0CC7-45AF-BA55-49A3C46B466F}" dt="2024-08-25T06:25:31.775" v="208" actId="20577"/>
          <ac:spMkLst>
            <pc:docMk/>
            <pc:sldMk cId="307993105" sldId="256"/>
            <ac:spMk id="53" creationId="{93EE83F8-9CB1-B1A4-552B-B51C56948188}"/>
          </ac:spMkLst>
        </pc:spChg>
        <pc:spChg chg="del">
          <ac:chgData name="洋平 小澤" userId="16df1fc59ed41bf5" providerId="LiveId" clId="{BA561075-0CC7-45AF-BA55-49A3C46B466F}" dt="2024-08-25T04:46:21.716" v="5" actId="478"/>
          <ac:spMkLst>
            <pc:docMk/>
            <pc:sldMk cId="307993105" sldId="256"/>
            <ac:spMk id="54" creationId="{F3DC5B02-8572-D179-D6A4-2219EBA91B63}"/>
          </ac:spMkLst>
        </pc:spChg>
        <pc:spChg chg="del">
          <ac:chgData name="洋平 小澤" userId="16df1fc59ed41bf5" providerId="LiveId" clId="{BA561075-0CC7-45AF-BA55-49A3C46B466F}" dt="2024-08-25T04:46:21.716" v="5" actId="478"/>
          <ac:spMkLst>
            <pc:docMk/>
            <pc:sldMk cId="307993105" sldId="256"/>
            <ac:spMk id="57" creationId="{B35ED761-EDAA-1679-495B-2C350A956771}"/>
          </ac:spMkLst>
        </pc:spChg>
        <pc:spChg chg="add mod">
          <ac:chgData name="洋平 小澤" userId="16df1fc59ed41bf5" providerId="LiveId" clId="{BA561075-0CC7-45AF-BA55-49A3C46B466F}" dt="2024-08-25T04:54:08.483" v="188" actId="20577"/>
          <ac:spMkLst>
            <pc:docMk/>
            <pc:sldMk cId="307993105" sldId="256"/>
            <ac:spMk id="58" creationId="{5138E819-392D-B9E5-236A-82061DE137CA}"/>
          </ac:spMkLst>
        </pc:spChg>
        <pc:spChg chg="del">
          <ac:chgData name="洋平 小澤" userId="16df1fc59ed41bf5" providerId="LiveId" clId="{BA561075-0CC7-45AF-BA55-49A3C46B466F}" dt="2024-08-25T04:46:21.716" v="5" actId="478"/>
          <ac:spMkLst>
            <pc:docMk/>
            <pc:sldMk cId="307993105" sldId="256"/>
            <ac:spMk id="59" creationId="{F41CCA98-5356-68D6-7F28-6BC0D15B5303}"/>
          </ac:spMkLst>
        </pc:spChg>
        <pc:spChg chg="del">
          <ac:chgData name="洋平 小澤" userId="16df1fc59ed41bf5" providerId="LiveId" clId="{BA561075-0CC7-45AF-BA55-49A3C46B466F}" dt="2024-08-25T04:46:21.716" v="5" actId="478"/>
          <ac:spMkLst>
            <pc:docMk/>
            <pc:sldMk cId="307993105" sldId="256"/>
            <ac:spMk id="60" creationId="{FA640C37-9954-E89B-C226-46C4BB7FFA3E}"/>
          </ac:spMkLst>
        </pc:spChg>
        <pc:spChg chg="del">
          <ac:chgData name="洋平 小澤" userId="16df1fc59ed41bf5" providerId="LiveId" clId="{BA561075-0CC7-45AF-BA55-49A3C46B466F}" dt="2024-08-25T04:46:21.716" v="5" actId="478"/>
          <ac:spMkLst>
            <pc:docMk/>
            <pc:sldMk cId="307993105" sldId="256"/>
            <ac:spMk id="63" creationId="{09B59548-B466-D8A9-769C-63DAE92FA50A}"/>
          </ac:spMkLst>
        </pc:spChg>
        <pc:spChg chg="del">
          <ac:chgData name="洋平 小澤" userId="16df1fc59ed41bf5" providerId="LiveId" clId="{BA561075-0CC7-45AF-BA55-49A3C46B466F}" dt="2024-08-25T04:46:21.716" v="5" actId="478"/>
          <ac:spMkLst>
            <pc:docMk/>
            <pc:sldMk cId="307993105" sldId="256"/>
            <ac:spMk id="64" creationId="{25B0511E-3A2D-DB43-78CD-A4655CEE1780}"/>
          </ac:spMkLst>
        </pc:spChg>
        <pc:spChg chg="del">
          <ac:chgData name="洋平 小澤" userId="16df1fc59ed41bf5" providerId="LiveId" clId="{BA561075-0CC7-45AF-BA55-49A3C46B466F}" dt="2024-08-25T04:46:21.716" v="5" actId="478"/>
          <ac:spMkLst>
            <pc:docMk/>
            <pc:sldMk cId="307993105" sldId="256"/>
            <ac:spMk id="65" creationId="{A74928BC-5D80-ABAB-B49A-6D9D56630F5F}"/>
          </ac:spMkLst>
        </pc:spChg>
        <pc:spChg chg="del">
          <ac:chgData name="洋平 小澤" userId="16df1fc59ed41bf5" providerId="LiveId" clId="{BA561075-0CC7-45AF-BA55-49A3C46B466F}" dt="2024-08-25T04:46:21.716" v="5" actId="478"/>
          <ac:spMkLst>
            <pc:docMk/>
            <pc:sldMk cId="307993105" sldId="256"/>
            <ac:spMk id="66" creationId="{0ADAF836-8312-6257-7D47-A3A6567A5012}"/>
          </ac:spMkLst>
        </pc:spChg>
        <pc:spChg chg="del">
          <ac:chgData name="洋平 小澤" userId="16df1fc59ed41bf5" providerId="LiveId" clId="{BA561075-0CC7-45AF-BA55-49A3C46B466F}" dt="2024-08-25T04:46:21.716" v="5" actId="478"/>
          <ac:spMkLst>
            <pc:docMk/>
            <pc:sldMk cId="307993105" sldId="256"/>
            <ac:spMk id="68" creationId="{2B99A8C2-8425-54B7-3107-2ADD1245965C}"/>
          </ac:spMkLst>
        </pc:spChg>
        <pc:picChg chg="del">
          <ac:chgData name="洋平 小澤" userId="16df1fc59ed41bf5" providerId="LiveId" clId="{BA561075-0CC7-45AF-BA55-49A3C46B466F}" dt="2024-08-25T04:46:07.334" v="0" actId="478"/>
          <ac:picMkLst>
            <pc:docMk/>
            <pc:sldMk cId="307993105" sldId="256"/>
            <ac:picMk id="6" creationId="{826D1076-CDA5-AA44-7C79-943ACC0422B2}"/>
          </ac:picMkLst>
        </pc:picChg>
        <pc:picChg chg="add mod">
          <ac:chgData name="洋平 小澤" userId="16df1fc59ed41bf5" providerId="LiveId" clId="{BA561075-0CC7-45AF-BA55-49A3C46B466F}" dt="2024-08-25T04:48:59.108" v="59" actId="1076"/>
          <ac:picMkLst>
            <pc:docMk/>
            <pc:sldMk cId="307993105" sldId="256"/>
            <ac:picMk id="8" creationId="{A32E34FA-3CEC-A8B2-B1FE-96B8B6C59606}"/>
          </ac:picMkLst>
        </pc:picChg>
        <pc:picChg chg="add mod">
          <ac:chgData name="洋平 小澤" userId="16df1fc59ed41bf5" providerId="LiveId" clId="{BA561075-0CC7-45AF-BA55-49A3C46B466F}" dt="2024-08-25T04:54:29.010" v="191" actId="14100"/>
          <ac:picMkLst>
            <pc:docMk/>
            <pc:sldMk cId="307993105" sldId="256"/>
            <ac:picMk id="17" creationId="{900BEDA8-FBD3-F73C-EB1C-3624F04C08FB}"/>
          </ac:picMkLst>
        </pc:picChg>
        <pc:picChg chg="mod">
          <ac:chgData name="洋平 小澤" userId="16df1fc59ed41bf5" providerId="LiveId" clId="{BA561075-0CC7-45AF-BA55-49A3C46B466F}" dt="2024-08-25T04:46:37.938" v="6" actId="1076"/>
          <ac:picMkLst>
            <pc:docMk/>
            <pc:sldMk cId="307993105" sldId="256"/>
            <ac:picMk id="22" creationId="{5355C3D9-6421-F9B7-AF28-55B8E3E160E9}"/>
          </ac:picMkLst>
        </pc:picChg>
        <pc:picChg chg="del">
          <ac:chgData name="洋平 小澤" userId="16df1fc59ed41bf5" providerId="LiveId" clId="{BA561075-0CC7-45AF-BA55-49A3C46B466F}" dt="2024-08-25T04:46:15.932" v="3" actId="478"/>
          <ac:picMkLst>
            <pc:docMk/>
            <pc:sldMk cId="307993105" sldId="256"/>
            <ac:picMk id="25" creationId="{7EC3D4B1-86FB-418E-7CE6-FCE368481283}"/>
          </ac:picMkLst>
        </pc:picChg>
        <pc:picChg chg="mod">
          <ac:chgData name="洋平 小澤" userId="16df1fc59ed41bf5" providerId="LiveId" clId="{BA561075-0CC7-45AF-BA55-49A3C46B466F}" dt="2024-08-25T04:46:43.301" v="7" actId="1076"/>
          <ac:picMkLst>
            <pc:docMk/>
            <pc:sldMk cId="307993105" sldId="256"/>
            <ac:picMk id="30" creationId="{D2919288-D958-37D9-81DD-F11137CF04DA}"/>
          </ac:picMkLst>
        </pc:picChg>
        <pc:picChg chg="mod">
          <ac:chgData name="洋平 小澤" userId="16df1fc59ed41bf5" providerId="LiveId" clId="{BA561075-0CC7-45AF-BA55-49A3C46B466F}" dt="2024-08-25T04:46:43.301" v="7" actId="1076"/>
          <ac:picMkLst>
            <pc:docMk/>
            <pc:sldMk cId="307993105" sldId="256"/>
            <ac:picMk id="37" creationId="{D6232785-91D3-34E2-F586-F393653F2D28}"/>
          </ac:picMkLst>
        </pc:picChg>
        <pc:picChg chg="mod">
          <ac:chgData name="洋平 小澤" userId="16df1fc59ed41bf5" providerId="LiveId" clId="{BA561075-0CC7-45AF-BA55-49A3C46B466F}" dt="2024-08-25T04:49:21.219" v="61" actId="1076"/>
          <ac:picMkLst>
            <pc:docMk/>
            <pc:sldMk cId="307993105" sldId="256"/>
            <ac:picMk id="42" creationId="{94A48E72-4A48-69B5-9EB3-D08216C0D015}"/>
          </ac:picMkLst>
        </pc:picChg>
        <pc:picChg chg="del">
          <ac:chgData name="洋平 小澤" userId="16df1fc59ed41bf5" providerId="LiveId" clId="{BA561075-0CC7-45AF-BA55-49A3C46B466F}" dt="2024-08-25T04:46:21.716" v="5" actId="478"/>
          <ac:picMkLst>
            <pc:docMk/>
            <pc:sldMk cId="307993105" sldId="256"/>
            <ac:picMk id="47" creationId="{F00A2B79-60CE-8DDC-2FB2-C56DC8AF8776}"/>
          </ac:picMkLst>
        </pc:picChg>
        <pc:picChg chg="add mod ord">
          <ac:chgData name="洋平 小澤" userId="16df1fc59ed41bf5" providerId="LiveId" clId="{BA561075-0CC7-45AF-BA55-49A3C46B466F}" dt="2024-08-25T04:53:54.308" v="182" actId="167"/>
          <ac:picMkLst>
            <pc:docMk/>
            <pc:sldMk cId="307993105" sldId="256"/>
            <ac:picMk id="55" creationId="{3D1AD1D9-BDA7-754A-4D19-EC01AABB209F}"/>
          </ac:picMkLst>
        </pc:picChg>
        <pc:picChg chg="del">
          <ac:chgData name="洋平 小澤" userId="16df1fc59ed41bf5" providerId="LiveId" clId="{BA561075-0CC7-45AF-BA55-49A3C46B466F}" dt="2024-08-25T04:46:21.716" v="5" actId="478"/>
          <ac:picMkLst>
            <pc:docMk/>
            <pc:sldMk cId="307993105" sldId="256"/>
            <ac:picMk id="56" creationId="{AE4AE093-7D67-500C-2AC1-92FBA2902478}"/>
          </ac:picMkLst>
        </pc:picChg>
        <pc:picChg chg="del">
          <ac:chgData name="洋平 小澤" userId="16df1fc59ed41bf5" providerId="LiveId" clId="{BA561075-0CC7-45AF-BA55-49A3C46B466F}" dt="2024-08-25T04:46:21.716" v="5" actId="478"/>
          <ac:picMkLst>
            <pc:docMk/>
            <pc:sldMk cId="307993105" sldId="256"/>
            <ac:picMk id="62" creationId="{7273DBC7-B817-3855-BC62-7A3A51506151}"/>
          </ac:picMkLst>
        </pc:picChg>
      </pc:sldChg>
    </pc:docChg>
  </pc:docChgLst>
  <pc:docChgLst>
    <pc:chgData name="洋平 小澤" userId="16df1fc59ed41bf5" providerId="LiveId" clId="{F65B7094-7F67-49B4-B550-EFAFA77AF4FB}"/>
    <pc:docChg chg="delSld">
      <pc:chgData name="洋平 小澤" userId="16df1fc59ed41bf5" providerId="LiveId" clId="{F65B7094-7F67-49B4-B550-EFAFA77AF4FB}" dt="2024-06-26T08:37:41.638" v="1" actId="47"/>
      <pc:docMkLst>
        <pc:docMk/>
      </pc:docMkLst>
      <pc:sldChg chg="del">
        <pc:chgData name="洋平 小澤" userId="16df1fc59ed41bf5" providerId="LiveId" clId="{F65B7094-7F67-49B4-B550-EFAFA77AF4FB}" dt="2024-06-26T08:37:41.638" v="1" actId="47"/>
        <pc:sldMkLst>
          <pc:docMk/>
          <pc:sldMk cId="17581097" sldId="257"/>
        </pc:sldMkLst>
      </pc:sldChg>
      <pc:sldChg chg="del">
        <pc:chgData name="洋平 小澤" userId="16df1fc59ed41bf5" providerId="LiveId" clId="{F65B7094-7F67-49B4-B550-EFAFA77AF4FB}" dt="2024-06-26T08:37:40.854" v="0" actId="47"/>
        <pc:sldMkLst>
          <pc:docMk/>
          <pc:sldMk cId="1460991872" sldId="25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A0DC9-CD3F-42A2-A301-8530C2B6ACE6}" type="datetimeFigureOut">
              <a:rPr kumimoji="1" lang="ja-JP" altLang="en-US" smtClean="0"/>
              <a:t>2024/8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5A750-E88B-410B-B6BC-CC42F7784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2083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A0DC9-CD3F-42A2-A301-8530C2B6ACE6}" type="datetimeFigureOut">
              <a:rPr kumimoji="1" lang="ja-JP" altLang="en-US" smtClean="0"/>
              <a:t>2024/8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5A750-E88B-410B-B6BC-CC42F7784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84650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A0DC9-CD3F-42A2-A301-8530C2B6ACE6}" type="datetimeFigureOut">
              <a:rPr kumimoji="1" lang="ja-JP" altLang="en-US" smtClean="0"/>
              <a:t>2024/8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5A750-E88B-410B-B6BC-CC42F7784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3348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A0DC9-CD3F-42A2-A301-8530C2B6ACE6}" type="datetimeFigureOut">
              <a:rPr kumimoji="1" lang="ja-JP" altLang="en-US" smtClean="0"/>
              <a:t>2024/8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5A750-E88B-410B-B6BC-CC42F7784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0147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A0DC9-CD3F-42A2-A301-8530C2B6ACE6}" type="datetimeFigureOut">
              <a:rPr kumimoji="1" lang="ja-JP" altLang="en-US" smtClean="0"/>
              <a:t>2024/8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5A750-E88B-410B-B6BC-CC42F7784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205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A0DC9-CD3F-42A2-A301-8530C2B6ACE6}" type="datetimeFigureOut">
              <a:rPr kumimoji="1" lang="ja-JP" altLang="en-US" smtClean="0"/>
              <a:t>2024/8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5A750-E88B-410B-B6BC-CC42F7784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481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A0DC9-CD3F-42A2-A301-8530C2B6ACE6}" type="datetimeFigureOut">
              <a:rPr kumimoji="1" lang="ja-JP" altLang="en-US" smtClean="0"/>
              <a:t>2024/8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5A750-E88B-410B-B6BC-CC42F7784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9613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A0DC9-CD3F-42A2-A301-8530C2B6ACE6}" type="datetimeFigureOut">
              <a:rPr kumimoji="1" lang="ja-JP" altLang="en-US" smtClean="0"/>
              <a:t>2024/8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5A750-E88B-410B-B6BC-CC42F7784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0927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A0DC9-CD3F-42A2-A301-8530C2B6ACE6}" type="datetimeFigureOut">
              <a:rPr kumimoji="1" lang="ja-JP" altLang="en-US" smtClean="0"/>
              <a:t>2024/8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5A750-E88B-410B-B6BC-CC42F7784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6450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A0DC9-CD3F-42A2-A301-8530C2B6ACE6}" type="datetimeFigureOut">
              <a:rPr kumimoji="1" lang="ja-JP" altLang="en-US" smtClean="0"/>
              <a:t>2024/8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5A750-E88B-410B-B6BC-CC42F7784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8260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A0DC9-CD3F-42A2-A301-8530C2B6ACE6}" type="datetimeFigureOut">
              <a:rPr kumimoji="1" lang="ja-JP" altLang="en-US" smtClean="0"/>
              <a:t>2024/8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5A750-E88B-410B-B6BC-CC42F7784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087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A0DC9-CD3F-42A2-A301-8530C2B6ACE6}" type="datetimeFigureOut">
              <a:rPr kumimoji="1" lang="ja-JP" altLang="en-US" smtClean="0"/>
              <a:t>2024/8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5A750-E88B-410B-B6BC-CC42F7784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6699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図 54">
            <a:extLst>
              <a:ext uri="{FF2B5EF4-FFF2-40B4-BE49-F238E27FC236}">
                <a16:creationId xmlns:a16="http://schemas.microsoft.com/office/drawing/2014/main" id="{3D1AD1D9-BDA7-754A-4D19-EC01AABB209F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324731" y="4764934"/>
            <a:ext cx="2055648" cy="1634933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E6DBD0A-8A4C-AC28-56B1-C280E56967B9}"/>
              </a:ext>
            </a:extLst>
          </p:cNvPr>
          <p:cNvSpPr txBox="1"/>
          <p:nvPr/>
        </p:nvSpPr>
        <p:spPr>
          <a:xfrm>
            <a:off x="172238" y="345302"/>
            <a:ext cx="128112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1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sz="1013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13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</a:t>
            </a:r>
            <a:endParaRPr lang="ja-JP" altLang="en-US" sz="10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0A2250C-18E9-B99C-4DCA-4A39952E05BC}"/>
              </a:ext>
            </a:extLst>
          </p:cNvPr>
          <p:cNvSpPr txBox="1"/>
          <p:nvPr/>
        </p:nvSpPr>
        <p:spPr>
          <a:xfrm rot="16200000">
            <a:off x="-66179" y="1466492"/>
            <a:ext cx="675185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T (IU/L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4053658-9FB8-266A-95DE-3E80FE43FADE}"/>
              </a:ext>
            </a:extLst>
          </p:cNvPr>
          <p:cNvSpPr txBox="1"/>
          <p:nvPr/>
        </p:nvSpPr>
        <p:spPr>
          <a:xfrm>
            <a:off x="1018142" y="2341714"/>
            <a:ext cx="856325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F15 (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1DFB857-E3B4-B333-1272-239F96DAEF85}"/>
              </a:ext>
            </a:extLst>
          </p:cNvPr>
          <p:cNvSpPr txBox="1"/>
          <p:nvPr/>
        </p:nvSpPr>
        <p:spPr>
          <a:xfrm>
            <a:off x="543567" y="728456"/>
            <a:ext cx="169656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anine aminotransferase (ALT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図 21">
            <a:extLst>
              <a:ext uri="{FF2B5EF4-FFF2-40B4-BE49-F238E27FC236}">
                <a16:creationId xmlns:a16="http://schemas.microsoft.com/office/drawing/2014/main" id="{5355C3D9-6421-F9B7-AF28-55B8E3E160E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rcRect l="7966" b="10299"/>
          <a:stretch/>
        </p:blipFill>
        <p:spPr>
          <a:xfrm>
            <a:off x="384731" y="907331"/>
            <a:ext cx="1883978" cy="1434383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F61D4F1-CC8F-86A7-30AB-567DE34B06D3}"/>
              </a:ext>
            </a:extLst>
          </p:cNvPr>
          <p:cNvSpPr txBox="1"/>
          <p:nvPr/>
        </p:nvSpPr>
        <p:spPr>
          <a:xfrm>
            <a:off x="1702426" y="1995997"/>
            <a:ext cx="535724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143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図 29">
            <a:extLst>
              <a:ext uri="{FF2B5EF4-FFF2-40B4-BE49-F238E27FC236}">
                <a16:creationId xmlns:a16="http://schemas.microsoft.com/office/drawing/2014/main" id="{D2919288-D958-37D9-81DD-F11137CF04D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rcRect l="5796" b="11338"/>
          <a:stretch/>
        </p:blipFill>
        <p:spPr>
          <a:xfrm>
            <a:off x="2438981" y="894492"/>
            <a:ext cx="1950983" cy="1434383"/>
          </a:xfrm>
          <a:prstGeom prst="rect">
            <a:avLst/>
          </a:prstGeom>
        </p:spPr>
      </p:pic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E0E75626-CA42-57AA-37C5-44DEF470310C}"/>
              </a:ext>
            </a:extLst>
          </p:cNvPr>
          <p:cNvSpPr txBox="1"/>
          <p:nvPr/>
        </p:nvSpPr>
        <p:spPr>
          <a:xfrm>
            <a:off x="2967545" y="728456"/>
            <a:ext cx="107437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moglobin (Hb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2D647A6-2720-648A-1AB9-9F09CD80AE5A}"/>
              </a:ext>
            </a:extLst>
          </p:cNvPr>
          <p:cNvSpPr txBox="1"/>
          <p:nvPr/>
        </p:nvSpPr>
        <p:spPr>
          <a:xfrm>
            <a:off x="3126785" y="2318841"/>
            <a:ext cx="856325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F15 (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91EF125-3AD9-7D04-5F35-F386DD280A69}"/>
              </a:ext>
            </a:extLst>
          </p:cNvPr>
          <p:cNvSpPr txBox="1"/>
          <p:nvPr/>
        </p:nvSpPr>
        <p:spPr>
          <a:xfrm rot="16200000">
            <a:off x="2081737" y="1410915"/>
            <a:ext cx="596638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Hb (g/dL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3500B784-CB1E-964B-46CA-0C3281109D87}"/>
              </a:ext>
            </a:extLst>
          </p:cNvPr>
          <p:cNvSpPr txBox="1"/>
          <p:nvPr/>
        </p:nvSpPr>
        <p:spPr>
          <a:xfrm>
            <a:off x="3788435" y="2008084"/>
            <a:ext cx="535724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20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7" name="図 36">
            <a:extLst>
              <a:ext uri="{FF2B5EF4-FFF2-40B4-BE49-F238E27FC236}">
                <a16:creationId xmlns:a16="http://schemas.microsoft.com/office/drawing/2014/main" id="{D6232785-91D3-34E2-F586-F393653F2D2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rcRect l="6829" b="10634"/>
          <a:stretch/>
        </p:blipFill>
        <p:spPr>
          <a:xfrm>
            <a:off x="4649006" y="894493"/>
            <a:ext cx="1950983" cy="1461806"/>
          </a:xfrm>
          <a:prstGeom prst="rect">
            <a:avLst/>
          </a:prstGeom>
        </p:spPr>
      </p:pic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2A9EF1B-07A5-C1C4-81A2-05BE8C5F9E1C}"/>
              </a:ext>
            </a:extLst>
          </p:cNvPr>
          <p:cNvSpPr txBox="1"/>
          <p:nvPr/>
        </p:nvSpPr>
        <p:spPr>
          <a:xfrm>
            <a:off x="5299124" y="2331581"/>
            <a:ext cx="856325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F15 (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8401D04-C627-6B0E-C283-69326A68C250}"/>
              </a:ext>
            </a:extLst>
          </p:cNvPr>
          <p:cNvSpPr txBox="1"/>
          <p:nvPr/>
        </p:nvSpPr>
        <p:spPr>
          <a:xfrm>
            <a:off x="5386153" y="728456"/>
            <a:ext cx="650526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telet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1959F97-4E9A-2A25-D878-7F58847F4595}"/>
              </a:ext>
            </a:extLst>
          </p:cNvPr>
          <p:cNvSpPr txBox="1"/>
          <p:nvPr/>
        </p:nvSpPr>
        <p:spPr>
          <a:xfrm rot="16200000">
            <a:off x="4106301" y="1410914"/>
            <a:ext cx="965798" cy="2135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telet (×10</a:t>
            </a:r>
            <a:r>
              <a:rPr lang="en-US" altLang="ja-JP" sz="788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2" name="図 41">
            <a:extLst>
              <a:ext uri="{FF2B5EF4-FFF2-40B4-BE49-F238E27FC236}">
                <a16:creationId xmlns:a16="http://schemas.microsoft.com/office/drawing/2014/main" id="{94A48E72-4A48-69B5-9EB3-D08216C0D01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rcRect l="6547" b="11389"/>
          <a:stretch/>
        </p:blipFill>
        <p:spPr>
          <a:xfrm>
            <a:off x="296451" y="2856060"/>
            <a:ext cx="2055648" cy="1438441"/>
          </a:xfrm>
          <a:prstGeom prst="rect">
            <a:avLst/>
          </a:prstGeom>
        </p:spPr>
      </p:pic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2E9381F-A69F-DB4D-751B-0410A2ABB17C}"/>
              </a:ext>
            </a:extLst>
          </p:cNvPr>
          <p:cNvSpPr txBox="1"/>
          <p:nvPr/>
        </p:nvSpPr>
        <p:spPr>
          <a:xfrm>
            <a:off x="801347" y="2690024"/>
            <a:ext cx="145667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te blood cell (WBC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4931E3E7-411A-358B-A3D8-14BC9D47E98C}"/>
              </a:ext>
            </a:extLst>
          </p:cNvPr>
          <p:cNvSpPr txBox="1"/>
          <p:nvPr/>
        </p:nvSpPr>
        <p:spPr>
          <a:xfrm>
            <a:off x="1041656" y="4315171"/>
            <a:ext cx="856325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F15 (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6C102864-D026-F21E-8F9A-78208F9DF795}"/>
              </a:ext>
            </a:extLst>
          </p:cNvPr>
          <p:cNvSpPr txBox="1"/>
          <p:nvPr/>
        </p:nvSpPr>
        <p:spPr>
          <a:xfrm rot="16200000">
            <a:off x="-104661" y="3344839"/>
            <a:ext cx="767936" cy="2135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WBC (/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86F5AF9F-CB5C-6DD9-CEBB-51C52466F389}"/>
              </a:ext>
            </a:extLst>
          </p:cNvPr>
          <p:cNvSpPr txBox="1"/>
          <p:nvPr/>
        </p:nvSpPr>
        <p:spPr>
          <a:xfrm>
            <a:off x="5991577" y="2026103"/>
            <a:ext cx="535724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55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93EE83F8-9CB1-B1A4-552B-B51C56948188}"/>
              </a:ext>
            </a:extLst>
          </p:cNvPr>
          <p:cNvSpPr txBox="1"/>
          <p:nvPr/>
        </p:nvSpPr>
        <p:spPr>
          <a:xfrm>
            <a:off x="1757737" y="3969652"/>
            <a:ext cx="535724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191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8146708-7A79-9AD1-86EF-DD95C9291D54}"/>
              </a:ext>
            </a:extLst>
          </p:cNvPr>
          <p:cNvSpPr txBox="1"/>
          <p:nvPr/>
        </p:nvSpPr>
        <p:spPr>
          <a:xfrm>
            <a:off x="2928772" y="2690024"/>
            <a:ext cx="134106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lymphocyte (TLC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DD27DB3-7746-8ED4-8216-7F2EDC30EEAD}"/>
              </a:ext>
            </a:extLst>
          </p:cNvPr>
          <p:cNvSpPr txBox="1"/>
          <p:nvPr/>
        </p:nvSpPr>
        <p:spPr>
          <a:xfrm>
            <a:off x="3198798" y="4278918"/>
            <a:ext cx="856325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F15 (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F778294-98D8-64E0-012A-EE67D816FBF0}"/>
              </a:ext>
            </a:extLst>
          </p:cNvPr>
          <p:cNvSpPr txBox="1"/>
          <p:nvPr/>
        </p:nvSpPr>
        <p:spPr>
          <a:xfrm rot="16200000">
            <a:off x="2055013" y="3344839"/>
            <a:ext cx="767936" cy="2135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C (/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A32E34FA-3CEC-A8B2-B1FE-96B8B6C59606}"/>
              </a:ext>
            </a:extLst>
          </p:cNvPr>
          <p:cNvPicPr>
            <a:picLocks noChangeAspect="1"/>
          </p:cNvPicPr>
          <p:nvPr/>
        </p:nvPicPr>
        <p:blipFill>
          <a:blip r:embed="rId7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2381775" y="2856060"/>
            <a:ext cx="2130308" cy="1602953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A2BCC27-050A-1B47-37FE-9BD607348A61}"/>
              </a:ext>
            </a:extLst>
          </p:cNvPr>
          <p:cNvSpPr txBox="1"/>
          <p:nvPr/>
        </p:nvSpPr>
        <p:spPr>
          <a:xfrm>
            <a:off x="4995877" y="2715917"/>
            <a:ext cx="145667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cholesterol (T-</a:t>
            </a:r>
            <a:r>
              <a:rPr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A1CA37E-75CA-2B3D-C308-DD6993B31E47}"/>
              </a:ext>
            </a:extLst>
          </p:cNvPr>
          <p:cNvSpPr txBox="1"/>
          <p:nvPr/>
        </p:nvSpPr>
        <p:spPr>
          <a:xfrm>
            <a:off x="5299124" y="4278918"/>
            <a:ext cx="856325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F15 (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97E75CC-4A71-6705-24B4-0E1F9CCBCDC2}"/>
              </a:ext>
            </a:extLst>
          </p:cNvPr>
          <p:cNvSpPr txBox="1"/>
          <p:nvPr/>
        </p:nvSpPr>
        <p:spPr>
          <a:xfrm rot="16200000">
            <a:off x="4183143" y="3253309"/>
            <a:ext cx="878491" cy="2135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g/dL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900BEDA8-FBD3-F73C-EB1C-3624F04C08FB}"/>
              </a:ext>
            </a:extLst>
          </p:cNvPr>
          <p:cNvPicPr>
            <a:picLocks noChangeAspect="1"/>
          </p:cNvPicPr>
          <p:nvPr/>
        </p:nvPicPr>
        <p:blipFill>
          <a:blip r:embed="rId8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4538117" y="2877216"/>
            <a:ext cx="2061872" cy="1578540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515D816-9CDB-C4F8-97DC-DC3E4B92F09B}"/>
              </a:ext>
            </a:extLst>
          </p:cNvPr>
          <p:cNvSpPr txBox="1"/>
          <p:nvPr/>
        </p:nvSpPr>
        <p:spPr>
          <a:xfrm>
            <a:off x="3855235" y="3955114"/>
            <a:ext cx="535724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997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977D0EC-48BA-C352-FC45-E15AE1C27091}"/>
              </a:ext>
            </a:extLst>
          </p:cNvPr>
          <p:cNvSpPr txBox="1"/>
          <p:nvPr/>
        </p:nvSpPr>
        <p:spPr>
          <a:xfrm>
            <a:off x="6036679" y="3957450"/>
            <a:ext cx="535724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90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36FA195-27AC-22AC-CCDF-A45081F83588}"/>
              </a:ext>
            </a:extLst>
          </p:cNvPr>
          <p:cNvSpPr txBox="1"/>
          <p:nvPr/>
        </p:nvSpPr>
        <p:spPr>
          <a:xfrm>
            <a:off x="1209667" y="4604263"/>
            <a:ext cx="4732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P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49BC9F0-514C-E998-3E8B-12BA18D299D6}"/>
              </a:ext>
            </a:extLst>
          </p:cNvPr>
          <p:cNvSpPr txBox="1"/>
          <p:nvPr/>
        </p:nvSpPr>
        <p:spPr>
          <a:xfrm>
            <a:off x="1041656" y="6192132"/>
            <a:ext cx="856325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F15 (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C2C22BE3-AAFD-89F3-1DB0-DE8DA086265D}"/>
              </a:ext>
            </a:extLst>
          </p:cNvPr>
          <p:cNvSpPr txBox="1"/>
          <p:nvPr/>
        </p:nvSpPr>
        <p:spPr>
          <a:xfrm rot="16200000">
            <a:off x="-61040" y="5227741"/>
            <a:ext cx="878491" cy="2135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P (mg/dL)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5138E819-392D-B9E5-236A-82061DE137CA}"/>
              </a:ext>
            </a:extLst>
          </p:cNvPr>
          <p:cNvSpPr txBox="1"/>
          <p:nvPr/>
        </p:nvSpPr>
        <p:spPr>
          <a:xfrm>
            <a:off x="1606605" y="5842899"/>
            <a:ext cx="535724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47</a:t>
            </a:r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993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9</TotalTime>
  <Words>132</Words>
  <Application>Microsoft Office PowerPoint</Application>
  <PresentationFormat>A4 210 x 297 mm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洋平 小澤</dc:creator>
  <cp:lastModifiedBy>洋平 小澤</cp:lastModifiedBy>
  <cp:revision>2</cp:revision>
  <cp:lastPrinted>2024-06-24T14:03:09Z</cp:lastPrinted>
  <dcterms:created xsi:type="dcterms:W3CDTF">2024-01-06T12:19:20Z</dcterms:created>
  <dcterms:modified xsi:type="dcterms:W3CDTF">2024-08-25T06:25:42Z</dcterms:modified>
</cp:coreProperties>
</file>